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82296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06BA"/>
    <a:srgbClr val="B41CAD"/>
    <a:srgbClr val="CC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67" y="480"/>
      </p:cViewPr>
      <p:guideLst>
        <p:guide orient="horz" pos="2592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hu%20Lab\Dropbox%20(Zhu%20Lab)\Guang\Current\Zika%20virus\PPI\nature%20communication%2020180727\figure%20excel\Figure_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heet2!$D$2:$D$17</c:f>
              <c:numCache>
                <c:formatCode>General</c:formatCode>
                <c:ptCount val="1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</c:numCache>
            </c:numRef>
          </c:cat>
          <c:val>
            <c:numRef>
              <c:f>Sheet2!$E$2:$E$17</c:f>
              <c:numCache>
                <c:formatCode>General</c:formatCode>
                <c:ptCount val="16"/>
                <c:pt idx="0">
                  <c:v>152</c:v>
                </c:pt>
                <c:pt idx="1">
                  <c:v>75</c:v>
                </c:pt>
                <c:pt idx="2">
                  <c:v>74</c:v>
                </c:pt>
                <c:pt idx="3">
                  <c:v>39</c:v>
                </c:pt>
                <c:pt idx="4">
                  <c:v>27</c:v>
                </c:pt>
                <c:pt idx="5">
                  <c:v>34</c:v>
                </c:pt>
                <c:pt idx="6">
                  <c:v>19</c:v>
                </c:pt>
                <c:pt idx="7">
                  <c:v>15</c:v>
                </c:pt>
                <c:pt idx="8">
                  <c:v>20</c:v>
                </c:pt>
                <c:pt idx="9">
                  <c:v>16</c:v>
                </c:pt>
                <c:pt idx="10">
                  <c:v>19</c:v>
                </c:pt>
                <c:pt idx="11">
                  <c:v>17</c:v>
                </c:pt>
                <c:pt idx="12">
                  <c:v>17</c:v>
                </c:pt>
                <c:pt idx="13">
                  <c:v>9</c:v>
                </c:pt>
                <c:pt idx="14">
                  <c:v>24</c:v>
                </c:pt>
                <c:pt idx="15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40-4D64-93E0-CE8C9F1963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6584016"/>
        <c:axId val="356584576"/>
      </c:barChart>
      <c:catAx>
        <c:axId val="356584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356584576"/>
        <c:crosses val="autoZero"/>
        <c:auto val="1"/>
        <c:lblAlgn val="ctr"/>
        <c:lblOffset val="100"/>
        <c:noMultiLvlLbl val="0"/>
      </c:catAx>
      <c:valAx>
        <c:axId val="356584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356584016"/>
        <c:crosses val="autoZero"/>
        <c:crossBetween val="between"/>
        <c:majorUnit val="4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6443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64" y="1"/>
            <a:ext cx="2946443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DD845F-52C8-4595-B7C2-FB54F2C18CDA}" type="datetimeFigureOut">
              <a:rPr lang="en-US" smtClean="0"/>
              <a:t>12/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39875" y="1241425"/>
            <a:ext cx="3719513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51" y="4776856"/>
            <a:ext cx="5438140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273"/>
            <a:ext cx="2946443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64" y="9428273"/>
            <a:ext cx="2946443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3C237B-B0C6-4183-AEF1-C2837E113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476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539875" y="1241425"/>
            <a:ext cx="3719513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3C237B-B0C6-4183-AEF1-C2837E1132A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4984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56511"/>
            <a:ext cx="7772400" cy="176403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663440"/>
            <a:ext cx="640080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29566"/>
            <a:ext cx="2057400" cy="702183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29566"/>
            <a:ext cx="6019800" cy="702183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288281"/>
            <a:ext cx="7772400" cy="163449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488056"/>
            <a:ext cx="777240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20240"/>
            <a:ext cx="4038600" cy="54311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20240"/>
            <a:ext cx="4038600" cy="54311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842136"/>
            <a:ext cx="4040188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609850"/>
            <a:ext cx="4040188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842136"/>
            <a:ext cx="4041775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609850"/>
            <a:ext cx="4041775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27660"/>
            <a:ext cx="3008313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27660"/>
            <a:ext cx="5111750" cy="70237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722120"/>
            <a:ext cx="3008313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760720"/>
            <a:ext cx="548640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735330"/>
            <a:ext cx="548640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6440806"/>
            <a:ext cx="548640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29566"/>
            <a:ext cx="822960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920240"/>
            <a:ext cx="8229600" cy="5431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7627621"/>
            <a:ext cx="21336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7627621"/>
            <a:ext cx="28956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7627621"/>
            <a:ext cx="21336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" name="Chart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2684515"/>
              </p:ext>
            </p:extLst>
          </p:nvPr>
        </p:nvGraphicFramePr>
        <p:xfrm>
          <a:off x="1447800" y="1143000"/>
          <a:ext cx="3124200" cy="243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7" name="Group 16"/>
          <p:cNvGrpSpPr/>
          <p:nvPr/>
        </p:nvGrpSpPr>
        <p:grpSpPr>
          <a:xfrm>
            <a:off x="4876800" y="1066801"/>
            <a:ext cx="3463043" cy="1693834"/>
            <a:chOff x="4405598" y="2682629"/>
            <a:chExt cx="2772284" cy="1355971"/>
          </a:xfrm>
        </p:grpSpPr>
        <p:sp>
          <p:nvSpPr>
            <p:cNvPr id="5" name="TextBox 4"/>
            <p:cNvSpPr txBox="1"/>
            <p:nvPr/>
          </p:nvSpPr>
          <p:spPr>
            <a:xfrm>
              <a:off x="4441891" y="2682629"/>
              <a:ext cx="2598640" cy="184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405598" y="2905268"/>
              <a:ext cx="850330" cy="271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his study</a:t>
              </a:r>
            </a:p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= 557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867400" y="2890244"/>
              <a:ext cx="1310482" cy="271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VirusMINT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&amp;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Virhostome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= 754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094129" y="3841642"/>
              <a:ext cx="956125" cy="1724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= 1.9 </a:t>
              </a:r>
              <a:r>
                <a:rPr lang="en-US" sz="800" dirty="0">
                  <a:latin typeface="Arial" panose="020B0604020202020204" pitchFamily="34" charset="0"/>
                  <a:ea typeface="OpenSymbol"/>
                  <a:cs typeface="Arial" panose="020B0604020202020204" pitchFamily="34" charset="0"/>
                </a:rPr>
                <a:t>×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4648200" y="3048000"/>
              <a:ext cx="1447800" cy="990600"/>
              <a:chOff x="4800600" y="4191000"/>
              <a:chExt cx="1447800" cy="990600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4876800" y="4572000"/>
                <a:ext cx="499741" cy="197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3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257800" y="4572000"/>
                <a:ext cx="499741" cy="197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4*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715000" y="4572000"/>
                <a:ext cx="499741" cy="197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0</a:t>
                </a:r>
              </a:p>
            </p:txBody>
          </p:sp>
          <p:grpSp>
            <p:nvGrpSpPr>
              <p:cNvPr id="13" name="Group 12"/>
              <p:cNvGrpSpPr/>
              <p:nvPr/>
            </p:nvGrpSpPr>
            <p:grpSpPr>
              <a:xfrm>
                <a:off x="4800600" y="4191000"/>
                <a:ext cx="1447800" cy="990600"/>
                <a:chOff x="5715000" y="4038600"/>
                <a:chExt cx="1447800" cy="990600"/>
              </a:xfrm>
            </p:grpSpPr>
            <p:sp>
              <p:nvSpPr>
                <p:cNvPr id="14" name="Oval 13"/>
                <p:cNvSpPr/>
                <p:nvPr/>
              </p:nvSpPr>
              <p:spPr>
                <a:xfrm>
                  <a:off x="5715000" y="4191000"/>
                  <a:ext cx="731520" cy="731520"/>
                </a:xfrm>
                <a:prstGeom prst="ellipse">
                  <a:avLst/>
                </a:prstGeom>
                <a:solidFill>
                  <a:schemeClr val="accent6">
                    <a:lumMod val="40000"/>
                    <a:lumOff val="60000"/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Oval 14"/>
                <p:cNvSpPr/>
                <p:nvPr/>
              </p:nvSpPr>
              <p:spPr>
                <a:xfrm>
                  <a:off x="6172200" y="4038600"/>
                  <a:ext cx="990600" cy="990600"/>
                </a:xfrm>
                <a:prstGeom prst="ellipse">
                  <a:avLst/>
                </a:prstGeom>
                <a:solidFill>
                  <a:schemeClr val="tx2">
                    <a:lumMod val="40000"/>
                    <a:lumOff val="60000"/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pic>
        <p:nvPicPr>
          <p:cNvPr id="16" name="Picture 2" descr="G:\project\zikapaper\20180422\figure2A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00" y="3086096"/>
            <a:ext cx="3429001" cy="37719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2" name="Group 31"/>
          <p:cNvGrpSpPr/>
          <p:nvPr/>
        </p:nvGrpSpPr>
        <p:grpSpPr>
          <a:xfrm>
            <a:off x="1600200" y="4267200"/>
            <a:ext cx="3053415" cy="1981200"/>
            <a:chOff x="4953000" y="228600"/>
            <a:chExt cx="3053415" cy="1981200"/>
          </a:xfrm>
        </p:grpSpPr>
        <p:sp>
          <p:nvSpPr>
            <p:cNvPr id="2" name="Oval 1"/>
            <p:cNvSpPr/>
            <p:nvPr/>
          </p:nvSpPr>
          <p:spPr>
            <a:xfrm>
              <a:off x="5257800" y="838200"/>
              <a:ext cx="1371600" cy="1371600"/>
            </a:xfrm>
            <a:prstGeom prst="ellipse">
              <a:avLst/>
            </a:prstGeom>
            <a:solidFill>
              <a:schemeClr val="accent6">
                <a:lumMod val="40000"/>
                <a:lumOff val="60000"/>
                <a:alpha val="62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Oval 17"/>
            <p:cNvSpPr/>
            <p:nvPr/>
          </p:nvSpPr>
          <p:spPr>
            <a:xfrm>
              <a:off x="6172200" y="838200"/>
              <a:ext cx="1371600" cy="1371600"/>
            </a:xfrm>
            <a:prstGeom prst="ellipse">
              <a:avLst/>
            </a:prstGeom>
            <a:solidFill>
              <a:schemeClr val="accent3">
                <a:lumMod val="20000"/>
                <a:lumOff val="80000"/>
                <a:alpha val="62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Oval 20"/>
            <p:cNvSpPr/>
            <p:nvPr/>
          </p:nvSpPr>
          <p:spPr>
            <a:xfrm>
              <a:off x="5867400" y="228600"/>
              <a:ext cx="1097280" cy="1097280"/>
            </a:xfrm>
            <a:prstGeom prst="ellipse">
              <a:avLst/>
            </a:prstGeom>
            <a:solidFill>
              <a:schemeClr val="tx2">
                <a:lumMod val="20000"/>
                <a:lumOff val="80000"/>
                <a:alpha val="62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6248400" y="144780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64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248400" y="990600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867400" y="83820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553200" y="83820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096000" y="30480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33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334000" y="152400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14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934200" y="152400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495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4953000" y="1828800"/>
              <a:ext cx="51167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P-MS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7315200" y="1905000"/>
              <a:ext cx="69121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BioID</a:t>
              </a:r>
              <a:r>
                <a:rPr lang="en-US" sz="9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-MS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5410200" y="381000"/>
              <a:ext cx="56938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HuProt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1142999" y="990601"/>
            <a:ext cx="267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495798" y="990601"/>
            <a:ext cx="4343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uman proteins targeted by virus protein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142999" y="3886201"/>
            <a:ext cx="267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495799" y="3886201"/>
            <a:ext cx="267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920240" y="3459480"/>
            <a:ext cx="2286000" cy="228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irus protein</a:t>
            </a:r>
          </a:p>
        </p:txBody>
      </p:sp>
      <p:sp>
        <p:nvSpPr>
          <p:cNvPr id="39" name="TextBox 38"/>
          <p:cNvSpPr txBox="1"/>
          <p:nvPr/>
        </p:nvSpPr>
        <p:spPr>
          <a:xfrm rot="16200000" flipH="1">
            <a:off x="701035" y="2118366"/>
            <a:ext cx="1417332" cy="228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inding human proteins</a:t>
            </a:r>
          </a:p>
        </p:txBody>
      </p:sp>
    </p:spTree>
    <p:extLst>
      <p:ext uri="{BB962C8B-B14F-4D97-AF65-F5344CB8AC3E}">
        <p14:creationId xmlns:p14="http://schemas.microsoft.com/office/powerpoint/2010/main" val="2294597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6</TotalTime>
  <Words>47</Words>
  <Application>Microsoft Office PowerPoint</Application>
  <PresentationFormat>自定义</PresentationFormat>
  <Paragraphs>2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OpenSymbol</vt:lpstr>
      <vt:lpstr>宋体</vt:lpstr>
      <vt:lpstr>Arial</vt:lpstr>
      <vt:lpstr>Calibri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bo</dc:creator>
  <cp:lastModifiedBy>谢珊珊</cp:lastModifiedBy>
  <cp:revision>79</cp:revision>
  <cp:lastPrinted>2020-12-09T04:50:12Z</cp:lastPrinted>
  <dcterms:created xsi:type="dcterms:W3CDTF">2006-08-16T00:00:00Z</dcterms:created>
  <dcterms:modified xsi:type="dcterms:W3CDTF">2020-12-09T04:53:21Z</dcterms:modified>
</cp:coreProperties>
</file>